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58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>
        <p:scale>
          <a:sx n="175" d="100"/>
          <a:sy n="175" d="100"/>
        </p:scale>
        <p:origin x="1104" y="-10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undley, Heather Ann" userId="9923bbf4-35ca-4515-b4c1-83653bfb90e1" providerId="ADAL" clId="{81655343-0A66-0147-BE9E-3DFD935E0F40}"/>
    <pc:docChg chg="modSld">
      <pc:chgData name="Hundley, Heather Ann" userId="9923bbf4-35ca-4515-b4c1-83653bfb90e1" providerId="ADAL" clId="{81655343-0A66-0147-BE9E-3DFD935E0F40}" dt="2023-11-25T14:27:15.113" v="53" actId="20577"/>
      <pc:docMkLst>
        <pc:docMk/>
      </pc:docMkLst>
      <pc:sldChg chg="modSp mod">
        <pc:chgData name="Hundley, Heather Ann" userId="9923bbf4-35ca-4515-b4c1-83653bfb90e1" providerId="ADAL" clId="{81655343-0A66-0147-BE9E-3DFD935E0F40}" dt="2023-11-25T14:27:15.113" v="53" actId="20577"/>
        <pc:sldMkLst>
          <pc:docMk/>
          <pc:sldMk cId="1757358524" sldId="258"/>
        </pc:sldMkLst>
        <pc:spChg chg="mod">
          <ac:chgData name="Hundley, Heather Ann" userId="9923bbf4-35ca-4515-b4c1-83653bfb90e1" providerId="ADAL" clId="{81655343-0A66-0147-BE9E-3DFD935E0F40}" dt="2023-11-25T14:27:15.113" v="53" actId="20577"/>
          <ac:spMkLst>
            <pc:docMk/>
            <pc:sldMk cId="1757358524" sldId="258"/>
            <ac:spMk id="9" creationId="{1F284C13-F55A-6834-099A-2590F72624DC}"/>
          </ac:spMkLst>
        </pc:spChg>
      </pc:sldChg>
    </pc:docChg>
  </pc:docChgLst>
  <pc:docChgLst>
    <pc:chgData name="Hundley, Heather Ann" userId="9923bbf4-35ca-4515-b4c1-83653bfb90e1" providerId="ADAL" clId="{C5B2845E-CF22-1444-B9DE-C3F730D3F9E7}"/>
    <pc:docChg chg="modSld">
      <pc:chgData name="Hundley, Heather Ann" userId="9923bbf4-35ca-4515-b4c1-83653bfb90e1" providerId="ADAL" clId="{C5B2845E-CF22-1444-B9DE-C3F730D3F9E7}" dt="2023-11-28T01:52:38.307" v="86" actId="20577"/>
      <pc:docMkLst>
        <pc:docMk/>
      </pc:docMkLst>
      <pc:sldChg chg="modSp mod">
        <pc:chgData name="Hundley, Heather Ann" userId="9923bbf4-35ca-4515-b4c1-83653bfb90e1" providerId="ADAL" clId="{C5B2845E-CF22-1444-B9DE-C3F730D3F9E7}" dt="2023-11-28T01:52:38.307" v="86" actId="20577"/>
        <pc:sldMkLst>
          <pc:docMk/>
          <pc:sldMk cId="1757358524" sldId="258"/>
        </pc:sldMkLst>
        <pc:spChg chg="mod">
          <ac:chgData name="Hundley, Heather Ann" userId="9923bbf4-35ca-4515-b4c1-83653bfb90e1" providerId="ADAL" clId="{C5B2845E-CF22-1444-B9DE-C3F730D3F9E7}" dt="2023-11-28T01:52:38.307" v="86" actId="20577"/>
          <ac:spMkLst>
            <pc:docMk/>
            <pc:sldMk cId="1757358524" sldId="258"/>
            <ac:spMk id="9" creationId="{1F284C13-F55A-6834-099A-2590F72624DC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156153-8435-475E-82F8-D26DF3FBEEC5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D67C22-2072-4A7D-A443-5B07EF0AE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944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6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04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59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33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154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20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220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41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51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3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5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74D95-4025-FA49-8DBA-B2DA07A2040A}" type="datetimeFigureOut">
              <a:rPr lang="en-US" smtClean="0"/>
              <a:t>11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46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1F284C13-F55A-6834-099A-2590F72624DC}"/>
              </a:ext>
            </a:extLst>
          </p:cNvPr>
          <p:cNvSpPr txBox="1"/>
          <p:nvPr/>
        </p:nvSpPr>
        <p:spPr>
          <a:xfrm>
            <a:off x="110764" y="4167792"/>
            <a:ext cx="7550871" cy="1066061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200" b="1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Additional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file 3: Fig.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S3.  </a:t>
            </a:r>
            <a:r>
              <a:rPr lang="en-US" sz="1200" b="1" i="1" dirty="0">
                <a:solidFill>
                  <a:srgbClr val="000000"/>
                </a:solidFill>
                <a:latin typeface="Arial"/>
                <a:cs typeface="Arial"/>
              </a:rPr>
              <a:t>adr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mutant animals are not sensitive to acute heat stress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.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 Each dot in the graph represents an independent biological replicate where the average </a:t>
            </a:r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percentage (%) alive 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for three </a:t>
            </a:r>
            <a:r>
              <a:rPr lang="en-US" sz="1200" dirty="0">
                <a:solidFill>
                  <a:srgbClr val="000000"/>
                </a:solidFill>
                <a:latin typeface="Arial"/>
                <a:cs typeface="Arial"/>
              </a:rPr>
              <a:t>technical</a:t>
            </a:r>
            <a:r>
              <a:rPr lang="en-US" sz="1200" b="0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 replicates was calculated. Error bars represent SEM. Statistical significance was determined using ordinary one-way ANOVA, Dunnett’s multiple </a:t>
            </a:r>
            <a:r>
              <a:rPr lang="en-US" sz="1200" b="0" i="0">
                <a:solidFill>
                  <a:srgbClr val="000000"/>
                </a:solidFill>
                <a:effectLst/>
                <a:latin typeface="Arial"/>
                <a:cs typeface="Arial"/>
              </a:rPr>
              <a:t>comparisons test</a:t>
            </a:r>
            <a:r>
              <a:rPr lang="en-US" sz="1200">
                <a:solidFill>
                  <a:srgbClr val="000000"/>
                </a:solidFill>
                <a:latin typeface="Arial"/>
                <a:cs typeface="Arial"/>
              </a:rPr>
              <a:t>, </a:t>
            </a:r>
            <a:r>
              <a:rPr lang="en-US" sz="1200" b="0" i="0" dirty="0">
                <a:effectLst/>
                <a:latin typeface="Arial"/>
                <a:cs typeface="Arial"/>
              </a:rPr>
              <a:t>*</a:t>
            </a:r>
            <a:r>
              <a:rPr lang="en-US" sz="1200" b="0" i="1" dirty="0">
                <a:effectLst/>
                <a:latin typeface="Arial"/>
                <a:cs typeface="Arial"/>
              </a:rPr>
              <a:t>p</a:t>
            </a:r>
            <a:r>
              <a:rPr lang="en-US" sz="1200" dirty="0">
                <a:latin typeface="Arial"/>
                <a:cs typeface="Arial"/>
              </a:rPr>
              <a:t>&lt;</a:t>
            </a:r>
            <a:r>
              <a:rPr lang="en-US" sz="1200" b="0" i="0" dirty="0">
                <a:effectLst/>
                <a:latin typeface="Arial"/>
                <a:cs typeface="Arial"/>
              </a:rPr>
              <a:t>0.05, **</a:t>
            </a:r>
            <a:r>
              <a:rPr lang="en-US" sz="1200" b="0" i="1" dirty="0">
                <a:effectLst/>
                <a:latin typeface="Arial"/>
                <a:cs typeface="Arial"/>
              </a:rPr>
              <a:t>p</a:t>
            </a:r>
            <a:r>
              <a:rPr lang="en-US" sz="1200" b="0" i="0" dirty="0">
                <a:effectLst/>
                <a:latin typeface="Arial"/>
                <a:cs typeface="Arial"/>
              </a:rPr>
              <a:t>&lt;0.005.</a:t>
            </a:r>
            <a:r>
              <a:rPr lang="en-US" sz="1200" dirty="0">
                <a:latin typeface="Arial"/>
                <a:cs typeface="Arial"/>
              </a:rPr>
              <a:t> </a:t>
            </a:r>
            <a:endParaRPr lang="en-US" sz="1200" dirty="0"/>
          </a:p>
          <a:p>
            <a:pPr>
              <a:lnSpc>
                <a:spcPct val="107000"/>
              </a:lnSpc>
            </a:pPr>
            <a:endParaRPr lang="en-US" sz="1200" dirty="0">
              <a:effectLst/>
              <a:latin typeface="Arial"/>
              <a:ea typeface="Calibri" panose="020F0502020204030204" pitchFamily="34" charset="0"/>
              <a:cs typeface="Arial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0CA897B-B315-AEB5-844E-70268C17B9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0154" y="445953"/>
            <a:ext cx="3421318" cy="37218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7358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3</TotalTime>
  <Words>71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Alfa</dc:creator>
  <cp:lastModifiedBy>Hundley, Heather Ann</cp:lastModifiedBy>
  <cp:revision>115</cp:revision>
  <cp:lastPrinted>2023-01-31T14:45:13Z</cp:lastPrinted>
  <dcterms:created xsi:type="dcterms:W3CDTF">2022-10-06T21:20:44Z</dcterms:created>
  <dcterms:modified xsi:type="dcterms:W3CDTF">2023-11-28T01:52:39Z</dcterms:modified>
</cp:coreProperties>
</file>